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92" d="100"/>
          <a:sy n="92" d="100"/>
        </p:scale>
        <p:origin x="-1384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ManuscriptsRice:PTPpaper:120229MKK4DD:120229MKK4DDed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ManuscriptsRice:PTPpaper:120229MKK4DD:120229MKK4DDed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ManuscriptsRice:PTPpaper:120229MKK4DD:120229MKK4DDed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1 (2)'!$I$14</c:f>
              <c:strCache>
                <c:ptCount val="1"/>
                <c:pt idx="0">
                  <c:v>W45/Ub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heet1 (2)'!$K$15:$K$20</c:f>
                <c:numCache>
                  <c:formatCode>General</c:formatCode>
                  <c:ptCount val="6"/>
                  <c:pt idx="0">
                    <c:v>0.0004099603</c:v>
                  </c:pt>
                  <c:pt idx="1">
                    <c:v>0.0003664445</c:v>
                  </c:pt>
                  <c:pt idx="2">
                    <c:v>6.978289E-5</c:v>
                  </c:pt>
                  <c:pt idx="3">
                    <c:v>0.00011851</c:v>
                  </c:pt>
                  <c:pt idx="4">
                    <c:v>6.276602E-5</c:v>
                  </c:pt>
                  <c:pt idx="5">
                    <c:v>1.146919E-5</c:v>
                  </c:pt>
                </c:numCache>
              </c:numRef>
            </c:plus>
            <c:minus>
              <c:numRef>
                <c:f>'Sheet1 (2)'!$J$15:$J$20</c:f>
                <c:numCache>
                  <c:formatCode>General</c:formatCode>
                  <c:ptCount val="6"/>
                  <c:pt idx="0">
                    <c:v>0.0003555214</c:v>
                  </c:pt>
                  <c:pt idx="1">
                    <c:v>0.000317252</c:v>
                  </c:pt>
                  <c:pt idx="2">
                    <c:v>6.289914E-5</c:v>
                  </c:pt>
                  <c:pt idx="3">
                    <c:v>9.999005E-5</c:v>
                  </c:pt>
                  <c:pt idx="4">
                    <c:v>5.518887E-5</c:v>
                  </c:pt>
                  <c:pt idx="5">
                    <c:v>1.039317E-5</c:v>
                  </c:pt>
                </c:numCache>
              </c:numRef>
            </c:minus>
          </c:errBars>
          <c:cat>
            <c:multiLvlStrRef>
              <c:f>'Sheet1 (2)'!$G$15:$H$20</c:f>
              <c:multiLvlStrCache>
                <c:ptCount val="6"/>
                <c:lvl>
                  <c:pt idx="0">
                    <c:v>6 h</c:v>
                  </c:pt>
                  <c:pt idx="1">
                    <c:v>12 h</c:v>
                  </c:pt>
                  <c:pt idx="2">
                    <c:v>0 h</c:v>
                  </c:pt>
                  <c:pt idx="3">
                    <c:v>2 h</c:v>
                  </c:pt>
                  <c:pt idx="4">
                    <c:v>6 h</c:v>
                  </c:pt>
                  <c:pt idx="5">
                    <c:v>12 h</c:v>
                  </c:pt>
                </c:lvl>
                <c:lvl>
                  <c:pt idx="0">
                    <c:v>mock</c:v>
                  </c:pt>
                  <c:pt idx="2">
                    <c:v>Dex</c:v>
                  </c:pt>
                </c:lvl>
              </c:multiLvlStrCache>
            </c:multiLvlStrRef>
          </c:cat>
          <c:val>
            <c:numRef>
              <c:f>'Sheet1 (2)'!$I$15:$I$20</c:f>
              <c:numCache>
                <c:formatCode>General</c:formatCode>
                <c:ptCount val="6"/>
                <c:pt idx="0">
                  <c:v>0.002677314</c:v>
                </c:pt>
                <c:pt idx="1">
                  <c:v>0.002363272</c:v>
                </c:pt>
                <c:pt idx="2">
                  <c:v>0.000637627</c:v>
                </c:pt>
                <c:pt idx="3">
                  <c:v>0.0006398403</c:v>
                </c:pt>
                <c:pt idx="4">
                  <c:v>0.0004571638</c:v>
                </c:pt>
                <c:pt idx="5">
                  <c:v>0.00011078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4947912"/>
        <c:axId val="2111731352"/>
      </c:barChart>
      <c:catAx>
        <c:axId val="-2124947912"/>
        <c:scaling>
          <c:orientation val="minMax"/>
        </c:scaling>
        <c:delete val="0"/>
        <c:axPos val="b"/>
        <c:majorTickMark val="out"/>
        <c:minorTickMark val="none"/>
        <c:tickLblPos val="nextTo"/>
        <c:crossAx val="2111731352"/>
        <c:crosses val="autoZero"/>
        <c:auto val="1"/>
        <c:lblAlgn val="ctr"/>
        <c:lblOffset val="100"/>
        <c:noMultiLvlLbl val="0"/>
      </c:catAx>
      <c:valAx>
        <c:axId val="2111731352"/>
        <c:scaling>
          <c:orientation val="minMax"/>
          <c:max val="0.05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249479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1 (2)'!$I$2</c:f>
              <c:strCache>
                <c:ptCount val="1"/>
                <c:pt idx="0">
                  <c:v>PAL/Ub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heet1 (2)'!$K$3:$K$8</c:f>
                <c:numCache>
                  <c:formatCode>General</c:formatCode>
                  <c:ptCount val="6"/>
                  <c:pt idx="0">
                    <c:v>0.0001383256</c:v>
                  </c:pt>
                  <c:pt idx="1">
                    <c:v>0.000286021</c:v>
                  </c:pt>
                  <c:pt idx="2">
                    <c:v>0.0006479351</c:v>
                  </c:pt>
                  <c:pt idx="3">
                    <c:v>0.001955312</c:v>
                  </c:pt>
                  <c:pt idx="4">
                    <c:v>0.01263987</c:v>
                  </c:pt>
                  <c:pt idx="5">
                    <c:v>0.001827657</c:v>
                  </c:pt>
                </c:numCache>
              </c:numRef>
            </c:plus>
            <c:minus>
              <c:numRef>
                <c:f>'Sheet1 (2)'!$J$3:$J$8</c:f>
                <c:numCache>
                  <c:formatCode>General</c:formatCode>
                  <c:ptCount val="6"/>
                  <c:pt idx="0">
                    <c:v>0.0001328466</c:v>
                  </c:pt>
                  <c:pt idx="1">
                    <c:v>0.0002628169</c:v>
                  </c:pt>
                  <c:pt idx="2">
                    <c:v>0.0005871467</c:v>
                  </c:pt>
                  <c:pt idx="3">
                    <c:v>0.001779392</c:v>
                  </c:pt>
                  <c:pt idx="4">
                    <c:v>0.01121443</c:v>
                  </c:pt>
                  <c:pt idx="5">
                    <c:v>0.001788035</c:v>
                  </c:pt>
                </c:numCache>
              </c:numRef>
            </c:minus>
          </c:errBars>
          <c:cat>
            <c:multiLvlStrRef>
              <c:f>'Sheet1 (2)'!$G$3:$H$8</c:f>
              <c:multiLvlStrCache>
                <c:ptCount val="6"/>
                <c:lvl>
                  <c:pt idx="0">
                    <c:v>6 h</c:v>
                  </c:pt>
                  <c:pt idx="1">
                    <c:v>12 h</c:v>
                  </c:pt>
                  <c:pt idx="2">
                    <c:v>0 h</c:v>
                  </c:pt>
                  <c:pt idx="3">
                    <c:v>2 h</c:v>
                  </c:pt>
                  <c:pt idx="4">
                    <c:v>6 h</c:v>
                  </c:pt>
                  <c:pt idx="5">
                    <c:v>12 h</c:v>
                  </c:pt>
                </c:lvl>
                <c:lvl>
                  <c:pt idx="0">
                    <c:v>mock</c:v>
                  </c:pt>
                  <c:pt idx="2">
                    <c:v>Dex</c:v>
                  </c:pt>
                </c:lvl>
              </c:multiLvlStrCache>
            </c:multiLvlStrRef>
          </c:cat>
          <c:val>
            <c:numRef>
              <c:f>'Sheet1 (2)'!$I$3:$I$8</c:f>
              <c:numCache>
                <c:formatCode>General</c:formatCode>
                <c:ptCount val="6"/>
                <c:pt idx="0">
                  <c:v>0.003353777</c:v>
                </c:pt>
                <c:pt idx="1">
                  <c:v>0.003239529</c:v>
                </c:pt>
                <c:pt idx="2">
                  <c:v>0.00625836</c:v>
                </c:pt>
                <c:pt idx="3">
                  <c:v>0.01977745</c:v>
                </c:pt>
                <c:pt idx="4">
                  <c:v>0.09944193</c:v>
                </c:pt>
                <c:pt idx="5">
                  <c:v>0.082469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3735048"/>
        <c:axId val="-2124662152"/>
      </c:barChart>
      <c:catAx>
        <c:axId val="2113735048"/>
        <c:scaling>
          <c:orientation val="minMax"/>
        </c:scaling>
        <c:delete val="0"/>
        <c:axPos val="b"/>
        <c:majorTickMark val="out"/>
        <c:minorTickMark val="none"/>
        <c:tickLblPos val="nextTo"/>
        <c:crossAx val="-2124662152"/>
        <c:crosses val="autoZero"/>
        <c:auto val="1"/>
        <c:lblAlgn val="ctr"/>
        <c:lblOffset val="100"/>
        <c:noMultiLvlLbl val="0"/>
      </c:catAx>
      <c:valAx>
        <c:axId val="-21246621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1137350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1 (2)'!$I$14</c:f>
              <c:strCache>
                <c:ptCount val="1"/>
                <c:pt idx="0">
                  <c:v>W45/Ub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Sheet1 (2)'!$K$15:$K$20</c:f>
                <c:numCache>
                  <c:formatCode>General</c:formatCode>
                  <c:ptCount val="6"/>
                  <c:pt idx="0">
                    <c:v>0.0004099603</c:v>
                  </c:pt>
                  <c:pt idx="1">
                    <c:v>0.0003664445</c:v>
                  </c:pt>
                  <c:pt idx="2">
                    <c:v>6.978289E-5</c:v>
                  </c:pt>
                  <c:pt idx="3">
                    <c:v>0.00011851</c:v>
                  </c:pt>
                  <c:pt idx="4">
                    <c:v>6.276602E-5</c:v>
                  </c:pt>
                  <c:pt idx="5">
                    <c:v>1.146919E-5</c:v>
                  </c:pt>
                </c:numCache>
              </c:numRef>
            </c:plus>
            <c:minus>
              <c:numRef>
                <c:f>'Sheet1 (2)'!$J$15:$J$20</c:f>
                <c:numCache>
                  <c:formatCode>General</c:formatCode>
                  <c:ptCount val="6"/>
                  <c:pt idx="0">
                    <c:v>0.0003555214</c:v>
                  </c:pt>
                  <c:pt idx="1">
                    <c:v>0.000317252</c:v>
                  </c:pt>
                  <c:pt idx="2">
                    <c:v>6.289914E-5</c:v>
                  </c:pt>
                  <c:pt idx="3">
                    <c:v>9.999005E-5</c:v>
                  </c:pt>
                  <c:pt idx="4">
                    <c:v>5.518887E-5</c:v>
                  </c:pt>
                  <c:pt idx="5">
                    <c:v>1.039317E-5</c:v>
                  </c:pt>
                </c:numCache>
              </c:numRef>
            </c:minus>
          </c:errBars>
          <c:cat>
            <c:multiLvlStrRef>
              <c:f>'Sheet1 (2)'!$G$15:$H$20</c:f>
              <c:multiLvlStrCache>
                <c:ptCount val="6"/>
                <c:lvl>
                  <c:pt idx="0">
                    <c:v>6 h</c:v>
                  </c:pt>
                  <c:pt idx="1">
                    <c:v>12 h</c:v>
                  </c:pt>
                  <c:pt idx="2">
                    <c:v>0 h</c:v>
                  </c:pt>
                  <c:pt idx="3">
                    <c:v>2 h</c:v>
                  </c:pt>
                  <c:pt idx="4">
                    <c:v>6 h</c:v>
                  </c:pt>
                  <c:pt idx="5">
                    <c:v>12 h</c:v>
                  </c:pt>
                </c:lvl>
                <c:lvl>
                  <c:pt idx="0">
                    <c:v>mock</c:v>
                  </c:pt>
                  <c:pt idx="2">
                    <c:v>Dex</c:v>
                  </c:pt>
                </c:lvl>
              </c:multiLvlStrCache>
            </c:multiLvlStrRef>
          </c:cat>
          <c:val>
            <c:numRef>
              <c:f>'Sheet1 (2)'!$I$15:$I$20</c:f>
              <c:numCache>
                <c:formatCode>General</c:formatCode>
                <c:ptCount val="6"/>
                <c:pt idx="0">
                  <c:v>0.002677314</c:v>
                </c:pt>
                <c:pt idx="1">
                  <c:v>0.002363272</c:v>
                </c:pt>
                <c:pt idx="2">
                  <c:v>0.000637627</c:v>
                </c:pt>
                <c:pt idx="3">
                  <c:v>0.0006398403</c:v>
                </c:pt>
                <c:pt idx="4">
                  <c:v>0.0004571638</c:v>
                </c:pt>
                <c:pt idx="5">
                  <c:v>0.00011078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7811544"/>
        <c:axId val="-2107696216"/>
      </c:barChart>
      <c:catAx>
        <c:axId val="-2107811544"/>
        <c:scaling>
          <c:orientation val="minMax"/>
        </c:scaling>
        <c:delete val="0"/>
        <c:axPos val="b"/>
        <c:majorTickMark val="out"/>
        <c:minorTickMark val="none"/>
        <c:tickLblPos val="nextTo"/>
        <c:crossAx val="-2107696216"/>
        <c:crosses val="autoZero"/>
        <c:auto val="1"/>
        <c:lblAlgn val="ctr"/>
        <c:lblOffset val="100"/>
        <c:noMultiLvlLbl val="0"/>
      </c:catAx>
      <c:valAx>
        <c:axId val="-2107696216"/>
        <c:scaling>
          <c:orientation val="minMax"/>
          <c:max val="0.004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078115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54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75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05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49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9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58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89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5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56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43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109132" y="6962865"/>
            <a:ext cx="454551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/>
                <a:cs typeface="Times New Roman"/>
              </a:rPr>
              <a:t>S5 Fig. Gene expression in GVG</a:t>
            </a:r>
            <a:r>
              <a:rPr lang="en-US" altLang="ja-JP" sz="1050" i="1" dirty="0">
                <a:latin typeface="Times New Roman"/>
                <a:cs typeface="Times New Roman"/>
              </a:rPr>
              <a:t>-MKK4DD</a:t>
            </a:r>
            <a:r>
              <a:rPr lang="en-US" altLang="ja-JP" sz="1050" dirty="0">
                <a:latin typeface="Times New Roman"/>
                <a:cs typeface="Times New Roman"/>
              </a:rPr>
              <a:t> transformant cells. </a:t>
            </a:r>
            <a:endParaRPr lang="ja-JP" altLang="ja-JP" sz="1050" dirty="0">
              <a:latin typeface="Times New Roman"/>
              <a:cs typeface="Times New Roman"/>
            </a:endParaRPr>
          </a:p>
          <a:p>
            <a:r>
              <a:rPr lang="en-US" altLang="ja-JP" sz="1050" dirty="0">
                <a:latin typeface="Times New Roman"/>
                <a:cs typeface="Times New Roman"/>
              </a:rPr>
              <a:t>Transcript levels of </a:t>
            </a:r>
            <a:r>
              <a:rPr lang="en-US" altLang="ja-JP" sz="1050" i="1" dirty="0">
                <a:latin typeface="Times New Roman"/>
                <a:cs typeface="Times New Roman"/>
              </a:rPr>
              <a:t>WRKY45</a:t>
            </a:r>
            <a:r>
              <a:rPr lang="en-US" altLang="ja-JP" sz="1050" dirty="0">
                <a:latin typeface="Times New Roman"/>
                <a:cs typeface="Times New Roman"/>
              </a:rPr>
              <a:t> and </a:t>
            </a:r>
            <a:r>
              <a:rPr lang="en-US" altLang="ja-JP" sz="1050" i="1" dirty="0">
                <a:latin typeface="Times New Roman"/>
                <a:cs typeface="Times New Roman"/>
              </a:rPr>
              <a:t>phenylalanine ammonia-</a:t>
            </a:r>
            <a:r>
              <a:rPr lang="en-US" altLang="ja-JP" sz="1050" i="1" dirty="0" err="1">
                <a:latin typeface="Times New Roman"/>
                <a:cs typeface="Times New Roman"/>
              </a:rPr>
              <a:t>lyase</a:t>
            </a:r>
            <a:r>
              <a:rPr lang="en-US" altLang="ja-JP" sz="1050" dirty="0">
                <a:latin typeface="Times New Roman"/>
                <a:cs typeface="Times New Roman"/>
              </a:rPr>
              <a:t> (</a:t>
            </a:r>
            <a:r>
              <a:rPr lang="en-US" altLang="ja-JP" sz="1050" i="1" dirty="0">
                <a:latin typeface="Times New Roman"/>
                <a:cs typeface="Times New Roman"/>
              </a:rPr>
              <a:t>PAL</a:t>
            </a:r>
            <a:r>
              <a:rPr lang="en-US" altLang="ja-JP" sz="1050" dirty="0">
                <a:latin typeface="Times New Roman"/>
                <a:cs typeface="Times New Roman"/>
              </a:rPr>
              <a:t>) genes (relative to that of </a:t>
            </a:r>
            <a:r>
              <a:rPr lang="en-US" altLang="ja-JP" sz="1050" i="1" dirty="0">
                <a:latin typeface="Times New Roman"/>
                <a:cs typeface="Times New Roman"/>
              </a:rPr>
              <a:t>ubiquitin 1</a:t>
            </a:r>
            <a:r>
              <a:rPr lang="en-US" altLang="ja-JP" sz="1050" dirty="0">
                <a:latin typeface="Times New Roman"/>
                <a:cs typeface="Times New Roman"/>
              </a:rPr>
              <a:t>) were determined by qRT-PCR. The same results with different scale are shown for </a:t>
            </a:r>
            <a:r>
              <a:rPr lang="en-US" altLang="ja-JP" sz="1050" i="1" dirty="0">
                <a:latin typeface="Times New Roman"/>
                <a:cs typeface="Times New Roman"/>
              </a:rPr>
              <a:t>WRKY45</a:t>
            </a:r>
            <a:r>
              <a:rPr lang="en-US" altLang="ja-JP" sz="1050" dirty="0">
                <a:latin typeface="Times New Roman"/>
                <a:cs typeface="Times New Roman"/>
              </a:rPr>
              <a:t> in an inset.</a:t>
            </a:r>
            <a:endParaRPr lang="ja-JP" altLang="ja-JP" sz="1050" dirty="0">
              <a:latin typeface="Times New Roman"/>
              <a:cs typeface="Times New Roman"/>
            </a:endParaRPr>
          </a:p>
        </p:txBody>
      </p:sp>
      <p:graphicFrame>
        <p:nvGraphicFramePr>
          <p:cNvPr id="5" name="グラフ 4"/>
          <p:cNvGraphicFramePr/>
          <p:nvPr>
            <p:extLst>
              <p:ext uri="{D42A27DB-BD31-4B8C-83A1-F6EECF244321}">
                <p14:modId xmlns:p14="http://schemas.microsoft.com/office/powerpoint/2010/main" val="158914254"/>
              </p:ext>
            </p:extLst>
          </p:nvPr>
        </p:nvGraphicFramePr>
        <p:xfrm>
          <a:off x="1109132" y="880533"/>
          <a:ext cx="463973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/>
          <p:nvPr/>
        </p:nvGraphicFramePr>
        <p:xfrm>
          <a:off x="1109132" y="4064000"/>
          <a:ext cx="46101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テキスト ボックス 6"/>
          <p:cNvSpPr txBox="1"/>
          <p:nvPr/>
        </p:nvSpPr>
        <p:spPr>
          <a:xfrm rot="16200000">
            <a:off x="280591" y="1736714"/>
            <a:ext cx="10760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i="1" dirty="0" smtClean="0">
                <a:latin typeface="Helvetica"/>
                <a:cs typeface="Helvetica"/>
              </a:rPr>
              <a:t>WRKY45/Ubq</a:t>
            </a:r>
            <a:endParaRPr kumimoji="1" lang="ja-JP" altLang="en-US" sz="1050" b="1" i="1" dirty="0">
              <a:latin typeface="Helvetica"/>
              <a:cs typeface="Helvetica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431483" y="5054632"/>
            <a:ext cx="7742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i="1" dirty="0" smtClean="0">
                <a:latin typeface="Helvetica"/>
                <a:cs typeface="Helvetica"/>
              </a:rPr>
              <a:t>PAL/</a:t>
            </a:r>
            <a:r>
              <a:rPr lang="en-US" altLang="ja-JP" sz="1050" b="1" i="1" dirty="0" err="1" smtClean="0">
                <a:latin typeface="Helvetica"/>
                <a:cs typeface="Helvetica"/>
              </a:rPr>
              <a:t>Ubq</a:t>
            </a:r>
            <a:endParaRPr kumimoji="1" lang="ja-JP" altLang="en-US" sz="1050" b="1" i="1" dirty="0">
              <a:latin typeface="Helvetica"/>
              <a:cs typeface="Helvetica"/>
            </a:endParaRPr>
          </a:p>
        </p:txBody>
      </p:sp>
      <p:grpSp>
        <p:nvGrpSpPr>
          <p:cNvPr id="9" name="図形グループ 8"/>
          <p:cNvGrpSpPr/>
          <p:nvPr/>
        </p:nvGrpSpPr>
        <p:grpSpPr>
          <a:xfrm>
            <a:off x="2845831" y="921671"/>
            <a:ext cx="2873401" cy="1672474"/>
            <a:chOff x="6477980" y="880533"/>
            <a:chExt cx="2873401" cy="1672474"/>
          </a:xfrm>
        </p:grpSpPr>
        <p:sp>
          <p:nvSpPr>
            <p:cNvPr id="10" name="正方形/長方形 9"/>
            <p:cNvSpPr/>
            <p:nvPr/>
          </p:nvSpPr>
          <p:spPr>
            <a:xfrm>
              <a:off x="6477980" y="880533"/>
              <a:ext cx="2873401" cy="167247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aphicFrame>
          <p:nvGraphicFramePr>
            <p:cNvPr id="11" name="グラフ 10"/>
            <p:cNvGraphicFramePr/>
            <p:nvPr>
              <p:extLst>
                <p:ext uri="{D42A27DB-BD31-4B8C-83A1-F6EECF244321}">
                  <p14:modId xmlns:p14="http://schemas.microsoft.com/office/powerpoint/2010/main" val="909359299"/>
                </p:ext>
              </p:extLst>
            </p:nvPr>
          </p:nvGraphicFramePr>
          <p:xfrm>
            <a:off x="6651222" y="993153"/>
            <a:ext cx="2494916" cy="14085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41475343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0</TotalTime>
  <Words>60</Words>
  <Application>Microsoft Macintosh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辻 博志</dc:creator>
  <cp:lastModifiedBy>高辻 博志</cp:lastModifiedBy>
  <cp:revision>1</cp:revision>
  <dcterms:created xsi:type="dcterms:W3CDTF">2015-09-28T01:13:14Z</dcterms:created>
  <dcterms:modified xsi:type="dcterms:W3CDTF">2015-09-28T01:13:38Z</dcterms:modified>
</cp:coreProperties>
</file>